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5" d="100"/>
          <a:sy n="75" d="100"/>
        </p:scale>
        <p:origin x="84" y="8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313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946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043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036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182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425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389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853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455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64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377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F652FB-2DEF-484D-B0BB-1F672ACBFCBC}" type="datetimeFigureOut">
              <a:rPr lang="en-US" smtClean="0"/>
              <a:t>1/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406B64-0841-41D8-AFF2-A930B4ECA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328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1261577" y="1049097"/>
            <a:ext cx="9463009" cy="4846320"/>
            <a:chOff x="0" y="0"/>
            <a:chExt cx="7105650" cy="3636010"/>
          </a:xfrm>
        </p:grpSpPr>
        <p:grpSp>
          <p:nvGrpSpPr>
            <p:cNvPr id="3" name="Group 2"/>
            <p:cNvGrpSpPr/>
            <p:nvPr/>
          </p:nvGrpSpPr>
          <p:grpSpPr>
            <a:xfrm>
              <a:off x="457200" y="0"/>
              <a:ext cx="6648450" cy="3593465"/>
              <a:chOff x="0" y="0"/>
              <a:chExt cx="6648450" cy="3593465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89" t="2250" r="511" b="5490"/>
              <a:stretch/>
            </p:blipFill>
            <p:spPr bwMode="auto">
              <a:xfrm>
                <a:off x="9525" y="0"/>
                <a:ext cx="6638925" cy="1752600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360" t="1117" r="3357"/>
              <a:stretch/>
            </p:blipFill>
            <p:spPr bwMode="auto">
              <a:xfrm>
                <a:off x="0" y="1838325"/>
                <a:ext cx="6638925" cy="1755140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</p:grpSp>
        <p:sp>
          <p:nvSpPr>
            <p:cNvPr id="4" name="Text Box 2"/>
            <p:cNvSpPr txBox="1">
              <a:spLocks noChangeArrowheads="1"/>
            </p:cNvSpPr>
            <p:nvPr/>
          </p:nvSpPr>
          <p:spPr bwMode="auto">
            <a:xfrm>
              <a:off x="19050" y="590550"/>
              <a:ext cx="571500" cy="12261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ctr" anchorCtr="0">
              <a:noAutofit/>
            </a:bodyPr>
            <a:lstStyle/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ctA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ActA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ctB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ActB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ctC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ActC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ctE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ActE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 Box 2"/>
            <p:cNvSpPr txBox="1">
              <a:spLocks noChangeArrowheads="1"/>
            </p:cNvSpPr>
            <p:nvPr/>
          </p:nvSpPr>
          <p:spPr bwMode="auto">
            <a:xfrm>
              <a:off x="0" y="2409825"/>
              <a:ext cx="571500" cy="12261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ctr" anchorCtr="0">
              <a:noAutofit/>
            </a:bodyPr>
            <a:lstStyle/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ctA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ActA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ctB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ActB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ctC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ActC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ActE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just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900" b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ActE</a:t>
              </a:r>
              <a:endParaRPr lang="en-US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" name="Rectangle 7"/>
          <p:cNvSpPr/>
          <p:nvPr/>
        </p:nvSpPr>
        <p:spPr>
          <a:xfrm>
            <a:off x="2578570" y="375150"/>
            <a:ext cx="7425218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mino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id Alignments of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ure Mouse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Human </a:t>
            </a:r>
            <a:r>
              <a:rPr lang="en-US" b="1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tivin</a:t>
            </a:r>
            <a:r>
              <a:rPr lang="en-US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igands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57247" y="6077224"/>
            <a:ext cx="116059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S1 Fig. </a:t>
            </a:r>
            <a:r>
              <a:rPr lang="en-US" sz="1400" dirty="0" smtClean="0"/>
              <a:t>Alignment of Murine and Human Act A-E ligands. Note high degree of evolutionary conservation between mouse and human proteins. Conserved </a:t>
            </a:r>
            <a:r>
              <a:rPr lang="en-US" sz="1400" dirty="0" err="1" smtClean="0"/>
              <a:t>Cys</a:t>
            </a:r>
            <a:r>
              <a:rPr lang="en-US" sz="1400" dirty="0" smtClean="0"/>
              <a:t> residues are highlighted in </a:t>
            </a:r>
            <a:r>
              <a:rPr lang="en-US" sz="1400" dirty="0" smtClean="0">
                <a:solidFill>
                  <a:srgbClr val="6600CC"/>
                </a:solidFill>
              </a:rPr>
              <a:t>purple</a:t>
            </a:r>
            <a:r>
              <a:rPr lang="en-US" sz="1400" dirty="0" smtClean="0"/>
              <a:t>. 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661820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8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Children's Hospital of Philadelph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llings, Paul C</dc:creator>
  <cp:lastModifiedBy>Billings, Paul C</cp:lastModifiedBy>
  <cp:revision>6</cp:revision>
  <dcterms:created xsi:type="dcterms:W3CDTF">2020-01-02T21:58:58Z</dcterms:created>
  <dcterms:modified xsi:type="dcterms:W3CDTF">2020-01-06T18:33:01Z</dcterms:modified>
</cp:coreProperties>
</file>